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8" r:id="rId4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253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095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387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76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935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343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331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859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967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417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23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584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F770A-C4C1-4C60-93AE-D99B1FCAF4FD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6019D-A266-4D07-B581-0DE7AE992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500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6AE9564-A1A1-131F-0651-9ED587159BF0}"/>
              </a:ext>
            </a:extLst>
          </p:cNvPr>
          <p:cNvSpPr txBox="1"/>
          <p:nvPr/>
        </p:nvSpPr>
        <p:spPr>
          <a:xfrm>
            <a:off x="675245" y="7949470"/>
            <a:ext cx="550750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 S1. CyQuant assays performed on OVCAR5 (A) and OVCAR8 (B) cells after 72 hours of treatment with NB-73 or NB-115.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9749727-EF8A-7BBE-78D1-134C880EBEDD}"/>
              </a:ext>
            </a:extLst>
          </p:cNvPr>
          <p:cNvSpPr txBox="1"/>
          <p:nvPr/>
        </p:nvSpPr>
        <p:spPr>
          <a:xfrm>
            <a:off x="956848" y="448217"/>
            <a:ext cx="445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D7A459-ACF4-AE70-4978-C61E5B05ADB7}"/>
              </a:ext>
            </a:extLst>
          </p:cNvPr>
          <p:cNvSpPr txBox="1"/>
          <p:nvPr/>
        </p:nvSpPr>
        <p:spPr>
          <a:xfrm>
            <a:off x="956848" y="3819068"/>
            <a:ext cx="445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FCBE7BB5-386B-BF3F-92E6-1D89FB7D3A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1683448"/>
              </p:ext>
            </p:extLst>
          </p:nvPr>
        </p:nvGraphicFramePr>
        <p:xfrm>
          <a:off x="1402692" y="651410"/>
          <a:ext cx="4052616" cy="2762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912656" imgH="3349443" progId="Prism10.Document">
                  <p:embed/>
                </p:oleObj>
              </mc:Choice>
              <mc:Fallback>
                <p:oleObj name="Prism 10" r:id="rId2" imgW="4912656" imgH="3349443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71F7457-FCD0-48BC-8B51-DE9C533AE8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02692" y="651410"/>
                        <a:ext cx="4052616" cy="2762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02580FE5-AB03-EE74-CDB1-90D041BDBB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6135335"/>
              </p:ext>
            </p:extLst>
          </p:nvPr>
        </p:nvGraphicFramePr>
        <p:xfrm>
          <a:off x="1278540" y="4173811"/>
          <a:ext cx="4414098" cy="3016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902217" imgH="3349443" progId="Prism10.Document">
                  <p:embed/>
                </p:oleObj>
              </mc:Choice>
              <mc:Fallback>
                <p:oleObj name="Prism 10" r:id="rId4" imgW="4902217" imgH="3349443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2EC4723-0652-22C4-D1A4-34251DF3AF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78540" y="4173811"/>
                        <a:ext cx="4414098" cy="3016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4883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8BF0241-9A47-DB09-AD1C-331EFA7A34D5}"/>
              </a:ext>
            </a:extLst>
          </p:cNvPr>
          <p:cNvSpPr txBox="1"/>
          <p:nvPr/>
        </p:nvSpPr>
        <p:spPr>
          <a:xfrm>
            <a:off x="294759" y="5644279"/>
            <a:ext cx="626848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 NB compound washout experiment in OVCAR4 cells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experiment schematic is as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n in Fig 7A.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stern blot analysis of FOXM1, FOXM1-P, CCNB1, and total protein expression in OVCAR4 cells treated with NB-73 or NB-115 for 48 hours after no washout, washout after 6 hours, or washout after 3 hours of drug exposure. Protein expression was normalized to total protein and are expressed relative to the DMSO control.  </a:t>
            </a: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yQuant cell viability assay data for OVCAR4 cells treated with NB-73 for 72 hours.  The three curves compare data from no washout (72 hours), 6 hours drug exposure then washout (6 hours), and 3 hours drug exposure then washout (3 hours).  IC50 values for each condition are indicated in brackets. Error bars indicate mean +/- SD, non-linear regression curve. </a:t>
            </a: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 in B, except for NB-115 treatment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CA0739-5655-734F-9454-164AFBD649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91042" y="1219461"/>
            <a:ext cx="2964674" cy="18612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DE0D38F-90F4-39CB-BAB6-B6DF126EB7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1042" y="3471446"/>
            <a:ext cx="2888474" cy="178205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0E4879B-E656-B557-75A0-BF75DB276BFA}"/>
              </a:ext>
            </a:extLst>
          </p:cNvPr>
          <p:cNvSpPr txBox="1"/>
          <p:nvPr/>
        </p:nvSpPr>
        <p:spPr>
          <a:xfrm>
            <a:off x="354916" y="1005122"/>
            <a:ext cx="445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09503C-C9F2-3834-F896-52259AF32505}"/>
              </a:ext>
            </a:extLst>
          </p:cNvPr>
          <p:cNvSpPr txBox="1"/>
          <p:nvPr/>
        </p:nvSpPr>
        <p:spPr>
          <a:xfrm>
            <a:off x="3568120" y="1005122"/>
            <a:ext cx="445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5EA618-3204-2612-B312-57E85C84FA65}"/>
              </a:ext>
            </a:extLst>
          </p:cNvPr>
          <p:cNvSpPr txBox="1"/>
          <p:nvPr/>
        </p:nvSpPr>
        <p:spPr>
          <a:xfrm>
            <a:off x="3568120" y="3302169"/>
            <a:ext cx="4458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5AC3396D-2886-8B53-2573-A5D97D1684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4149" y="1512953"/>
            <a:ext cx="3450635" cy="29994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77795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F8169A2-C4C0-2200-953D-56B898F8740F}"/>
              </a:ext>
            </a:extLst>
          </p:cNvPr>
          <p:cNvSpPr txBox="1"/>
          <p:nvPr/>
        </p:nvSpPr>
        <p:spPr>
          <a:xfrm>
            <a:off x="627032" y="8146343"/>
            <a:ext cx="588650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.  Cell cycle analyses of CAOV3 (A) and OVCAR4 (B) cells treated with NB compounds for 24 hours.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-values are two-way ANOVA with Dunnett’s correction for multiple comparisons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D75AF01-0740-6D81-EE5E-16572AFCE915}"/>
              </a:ext>
            </a:extLst>
          </p:cNvPr>
          <p:cNvSpPr txBox="1"/>
          <p:nvPr/>
        </p:nvSpPr>
        <p:spPr>
          <a:xfrm>
            <a:off x="803809" y="443659"/>
            <a:ext cx="558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71D83D-3323-5815-DB0C-C633136D17EC}"/>
              </a:ext>
            </a:extLst>
          </p:cNvPr>
          <p:cNvSpPr txBox="1"/>
          <p:nvPr/>
        </p:nvSpPr>
        <p:spPr>
          <a:xfrm>
            <a:off x="803809" y="3960849"/>
            <a:ext cx="558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8CCE54B-F245-5967-3385-4CA3165379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2807988"/>
              </p:ext>
            </p:extLst>
          </p:nvPr>
        </p:nvGraphicFramePr>
        <p:xfrm>
          <a:off x="1642473" y="628325"/>
          <a:ext cx="4149319" cy="32168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556301" imgH="3532303" progId="Prism10.Document">
                  <p:embed/>
                </p:oleObj>
              </mc:Choice>
              <mc:Fallback>
                <p:oleObj name="Prism 10" r:id="rId2" imgW="4556301" imgH="3532303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52A8F82-4F50-54CA-589A-CCA42CE9D8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42473" y="628325"/>
                        <a:ext cx="4149319" cy="32168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132F07D-DE3A-C03F-BAE0-599F8330E0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6792593"/>
              </p:ext>
            </p:extLst>
          </p:nvPr>
        </p:nvGraphicFramePr>
        <p:xfrm>
          <a:off x="1777733" y="3960849"/>
          <a:ext cx="3878798" cy="38929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345728" imgH="4361295" progId="Prism10.Document">
                  <p:embed/>
                </p:oleObj>
              </mc:Choice>
              <mc:Fallback>
                <p:oleObj name="Prism 10" r:id="rId4" imgW="4345728" imgH="4361295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2EB6871-99A7-22C3-EDFD-6EA7937206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77733" y="3960849"/>
                        <a:ext cx="3878798" cy="38929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27020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53</TotalTime>
  <Words>231</Words>
  <Application>Microsoft Office PowerPoint</Application>
  <PresentationFormat>Letter Paper (8.5x11 in)</PresentationFormat>
  <Paragraphs>10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pf, Adam R</dc:creator>
  <cp:lastModifiedBy>Karpf, Adam R</cp:lastModifiedBy>
  <cp:revision>130</cp:revision>
  <cp:lastPrinted>2024-03-06T23:14:55Z</cp:lastPrinted>
  <dcterms:created xsi:type="dcterms:W3CDTF">2023-11-29T20:18:34Z</dcterms:created>
  <dcterms:modified xsi:type="dcterms:W3CDTF">2024-04-04T17:27:09Z</dcterms:modified>
</cp:coreProperties>
</file>